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0" autoAdjust="0"/>
    <p:restoredTop sz="94660"/>
  </p:normalViewPr>
  <p:slideViewPr>
    <p:cSldViewPr snapToGrid="0">
      <p:cViewPr varScale="1">
        <p:scale>
          <a:sx n="69" d="100"/>
          <a:sy n="69" d="100"/>
        </p:scale>
        <p:origin x="560" y="4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840974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14880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65761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4686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49831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49582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15128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42901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69445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622833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1905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139017E-F560-41E7-87E6-801FCF4DDC31}" type="datetimeFigureOut">
              <a:rPr lang="en-US" smtClean="0"/>
              <a:t>3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5A7A2D-3E79-42FF-A3E5-6D8DCCA4A24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06223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5691871"/>
              </p:ext>
            </p:extLst>
          </p:nvPr>
        </p:nvGraphicFramePr>
        <p:xfrm>
          <a:off x="441036" y="1363806"/>
          <a:ext cx="11436928" cy="3161776"/>
        </p:xfrm>
        <a:graphic>
          <a:graphicData uri="http://schemas.openxmlformats.org/drawingml/2006/table">
            <a:tbl>
              <a:tblPr firstRow="1" bandRow="1">
                <a:tableStyleId>{073A0DAA-6AF3-43AB-8588-CEC1D06C72B9}</a:tableStyleId>
              </a:tblPr>
              <a:tblGrid>
                <a:gridCol w="3507699">
                  <a:extLst>
                    <a:ext uri="{9D8B030D-6E8A-4147-A177-3AD203B41FA5}">
                      <a16:colId xmlns:a16="http://schemas.microsoft.com/office/drawing/2014/main" val="808205651"/>
                    </a:ext>
                  </a:extLst>
                </a:gridCol>
                <a:gridCol w="2624331">
                  <a:extLst>
                    <a:ext uri="{9D8B030D-6E8A-4147-A177-3AD203B41FA5}">
                      <a16:colId xmlns:a16="http://schemas.microsoft.com/office/drawing/2014/main" val="2226942826"/>
                    </a:ext>
                  </a:extLst>
                </a:gridCol>
                <a:gridCol w="2605585">
                  <a:extLst>
                    <a:ext uri="{9D8B030D-6E8A-4147-A177-3AD203B41FA5}">
                      <a16:colId xmlns:a16="http://schemas.microsoft.com/office/drawing/2014/main" val="486020734"/>
                    </a:ext>
                  </a:extLst>
                </a:gridCol>
                <a:gridCol w="2699313">
                  <a:extLst>
                    <a:ext uri="{9D8B030D-6E8A-4147-A177-3AD203B41FA5}">
                      <a16:colId xmlns:a16="http://schemas.microsoft.com/office/drawing/2014/main" val="1750282026"/>
                    </a:ext>
                  </a:extLst>
                </a:gridCol>
              </a:tblGrid>
              <a:tr h="326642">
                <a:tc gridSpan="4">
                  <a:txBody>
                    <a:bodyPr/>
                    <a:lstStyle/>
                    <a:p>
                      <a:r>
                        <a:rPr lang="en-US" sz="150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lmonary</a:t>
                      </a:r>
                      <a:r>
                        <a:rPr lang="en-US" sz="1500" baseline="0" dirty="0" smtClean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Function Test Results of 12 month follow-up data</a:t>
                      </a:r>
                      <a:endParaRPr lang="en-US" sz="15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tx1"/>
                    </a:solidFill>
                  </a:tcPr>
                </a:tc>
                <a:tc hMerge="1"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500" dirty="0" smtClean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 sz="1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58997627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ulmonary Function Tests </a:t>
                      </a:r>
                      <a:endParaRPr lang="en-US" sz="1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dirty="0" smtClean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ea typeface="Calibri" panose="020F0502020204030204" pitchFamily="34" charset="0"/>
                          <a:cs typeface="Arial" panose="020B0604020202020204" pitchFamily="34" charset="0"/>
                        </a:rPr>
                        <a:t>Normal (N=42)</a:t>
                      </a: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normal (N=54)</a:t>
                      </a:r>
                      <a:endParaRPr lang="en-US" sz="1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nduction Abnormality (N=41)</a:t>
                      </a:r>
                      <a:endParaRPr lang="en-US" sz="15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1405626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1 (L)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57 ± 0.79</a:t>
                      </a:r>
                      <a:r>
                        <a:rPr lang="en-US" sz="1500" baseline="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endParaRPr lang="en-US" sz="15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4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86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5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85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55318558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VC (L) 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77 ± 0.95</a:t>
                      </a:r>
                      <a:endParaRPr lang="en-US" sz="15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99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.00 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00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0.97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7208162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1/FVC (%)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.4 ± 7.5</a:t>
                      </a:r>
                      <a:endParaRPr lang="en-US" sz="15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8.0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8.9 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.4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9.5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529694008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O2 Saturation</a:t>
                      </a:r>
                      <a:r>
                        <a:rPr lang="en-US" sz="15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)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 ± 1</a:t>
                      </a:r>
                      <a:endParaRPr lang="en-US" sz="1500" dirty="0" smtClean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8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11829832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1 </a:t>
                      </a:r>
                      <a:r>
                        <a:rPr lang="en-US" sz="15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 predicted)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4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9 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0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9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79312149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VC </a:t>
                      </a:r>
                      <a:r>
                        <a:rPr lang="en-US" sz="15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(% predicted)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2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8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6</a:t>
                      </a:r>
                      <a:r>
                        <a:rPr lang="en-US" sz="15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2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20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0044610"/>
                  </a:ext>
                </a:extLst>
              </a:tr>
              <a:tr h="326642"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EV1/FVC</a:t>
                      </a:r>
                      <a:r>
                        <a:rPr lang="en-US" sz="1500" baseline="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% predicted)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4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9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2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r>
                        <a:rPr lang="en-US" sz="15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 </a:t>
                      </a:r>
                      <a:r>
                        <a:rPr lang="en-US" sz="1500" dirty="0" smtClean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± 13</a:t>
                      </a:r>
                      <a:endParaRPr lang="en-US" sz="15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253324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607794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3</Words>
  <Application>Microsoft Office PowerPoint</Application>
  <PresentationFormat>Widescreen</PresentationFormat>
  <Paragraphs>3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CSF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ou, Samuel</dc:creator>
  <cp:lastModifiedBy>Kou, Samuel</cp:lastModifiedBy>
  <cp:revision>3</cp:revision>
  <dcterms:created xsi:type="dcterms:W3CDTF">2020-02-08T22:56:53Z</dcterms:created>
  <dcterms:modified xsi:type="dcterms:W3CDTF">2020-03-13T18:30:14Z</dcterms:modified>
</cp:coreProperties>
</file>